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0" r:id="rId1"/>
  </p:sldMasterIdLst>
  <p:sldIdLst>
    <p:sldId id="256" r:id="rId2"/>
  </p:sldIdLst>
  <p:sldSz cx="12192000" cy="155448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96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50" d="100"/>
          <a:sy n="50" d="100"/>
        </p:scale>
        <p:origin x="1500" y="30"/>
      </p:cViewPr>
      <p:guideLst>
        <p:guide orient="horz" pos="489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7" y="14508480"/>
            <a:ext cx="12188825" cy="103632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7" y="14357783"/>
            <a:ext cx="12188825" cy="14508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1720291"/>
            <a:ext cx="10058400" cy="8083296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10666" spc="-67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051" y="10099408"/>
            <a:ext cx="10058400" cy="25908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3200" cap="all" spc="267" baseline="0">
                <a:solidFill>
                  <a:schemeClr val="tx2"/>
                </a:solidFill>
                <a:latin typeface="+mj-lt"/>
              </a:defRPr>
            </a:lvl1pPr>
            <a:lvl2pPr marL="609585" indent="0" algn="ctr">
              <a:buNone/>
              <a:defRPr sz="3200"/>
            </a:lvl2pPr>
            <a:lvl3pPr marL="1219170" indent="0" algn="ctr">
              <a:buNone/>
              <a:defRPr sz="3200"/>
            </a:lvl3pPr>
            <a:lvl4pPr marL="1828754" indent="0" algn="ctr">
              <a:buNone/>
              <a:defRPr sz="2667"/>
            </a:lvl4pPr>
            <a:lvl5pPr marL="2438339" indent="0" algn="ctr">
              <a:buNone/>
              <a:defRPr sz="2667"/>
            </a:lvl5pPr>
            <a:lvl6pPr marL="3047924" indent="0" algn="ctr">
              <a:buNone/>
              <a:defRPr sz="2667"/>
            </a:lvl6pPr>
            <a:lvl7pPr marL="3657509" indent="0" algn="ctr">
              <a:buNone/>
              <a:defRPr sz="2667"/>
            </a:lvl7pPr>
            <a:lvl8pPr marL="4267093" indent="0" algn="ctr">
              <a:buNone/>
              <a:defRPr sz="2667"/>
            </a:lvl8pPr>
            <a:lvl9pPr marL="4876678" indent="0" algn="ctr">
              <a:buNone/>
              <a:defRPr sz="2667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9" y="984504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9359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892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7" y="14508480"/>
            <a:ext cx="12188825" cy="103632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7" y="14357783"/>
            <a:ext cx="12188825" cy="14508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940167"/>
            <a:ext cx="2628900" cy="1305015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940166"/>
            <a:ext cx="7734300" cy="13050152"/>
          </a:xfrm>
        </p:spPr>
        <p:txBody>
          <a:bodyPr vert="eaVert" lIns="45720" tIns="0" rIns="45720" bIns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248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941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7" y="14508480"/>
            <a:ext cx="12188825" cy="103632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7" y="14357783"/>
            <a:ext cx="12188825" cy="14508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1720291"/>
            <a:ext cx="10058400" cy="8083296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10666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0093757"/>
            <a:ext cx="10058400" cy="25908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3200" cap="all" spc="267" baseline="0">
                <a:solidFill>
                  <a:schemeClr val="tx2"/>
                </a:solidFill>
                <a:latin typeface="+mj-lt"/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9" y="984504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75740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1097280" y="649637"/>
            <a:ext cx="10058400" cy="328838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7280" y="4183664"/>
            <a:ext cx="4937760" cy="911961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4183669"/>
            <a:ext cx="4937760" cy="911961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63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1097280" y="649637"/>
            <a:ext cx="10058400" cy="328838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4184384"/>
            <a:ext cx="4937760" cy="1668906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667" b="0" cap="all" baseline="0">
                <a:solidFill>
                  <a:schemeClr val="tx2"/>
                </a:solidFill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80" y="5853291"/>
            <a:ext cx="4937760" cy="744998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17920" y="4184384"/>
            <a:ext cx="4937760" cy="1668906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667" b="0" cap="all" baseline="0">
                <a:solidFill>
                  <a:schemeClr val="tx2"/>
                </a:solidFill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920" y="5853291"/>
            <a:ext cx="4937760" cy="744998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83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259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77" y="14508480"/>
            <a:ext cx="12188825" cy="103632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7" y="14357783"/>
            <a:ext cx="12188825" cy="14508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764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8" y="0"/>
            <a:ext cx="4050791" cy="155448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4040071" y="0"/>
            <a:ext cx="64008" cy="155448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347214"/>
            <a:ext cx="3200400" cy="5181600"/>
          </a:xfrm>
        </p:spPr>
        <p:txBody>
          <a:bodyPr anchor="b">
            <a:normAutofit/>
          </a:bodyPr>
          <a:lstStyle>
            <a:lvl1pPr>
              <a:defRPr sz="4800" b="0">
                <a:solidFill>
                  <a:srgbClr val="FFFFFF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13650" y="1658112"/>
            <a:ext cx="6679191" cy="1191768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6632448"/>
            <a:ext cx="3200400" cy="7659348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2000">
                <a:solidFill>
                  <a:srgbClr val="FFFFFF"/>
                </a:solidFill>
              </a:defRPr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65513" y="14642183"/>
            <a:ext cx="2618511" cy="827617"/>
          </a:xfrm>
        </p:spPr>
        <p:txBody>
          <a:bodyPr/>
          <a:lstStyle>
            <a:lvl1pPr algn="l">
              <a:defRPr/>
            </a:lvl1pPr>
          </a:lstStyle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800600" y="14642183"/>
            <a:ext cx="4648200" cy="827617"/>
          </a:xfrm>
        </p:spPr>
        <p:txBody>
          <a:bodyPr/>
          <a:lstStyle>
            <a:lvl1pPr algn="l">
              <a:defRPr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823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" y="11226800"/>
            <a:ext cx="12188825" cy="431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7" y="11140839"/>
            <a:ext cx="12188825" cy="14508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11503152"/>
            <a:ext cx="10119360" cy="1865376"/>
          </a:xfrm>
        </p:spPr>
        <p:txBody>
          <a:bodyPr tIns="0" bIns="0" anchor="b">
            <a:noAutofit/>
          </a:bodyPr>
          <a:lstStyle>
            <a:lvl1pPr>
              <a:defRPr sz="4800" b="0">
                <a:solidFill>
                  <a:srgbClr val="FFFFFF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7" y="0"/>
            <a:ext cx="12191985" cy="11140839"/>
          </a:xfrm>
          <a:blipFill>
            <a:blip r:embed="rId2"/>
            <a:stretch>
              <a:fillRect/>
            </a:stretch>
          </a:blipFill>
        </p:spPr>
        <p:txBody>
          <a:bodyPr lIns="457200" tIns="457200" anchor="t"/>
          <a:lstStyle>
            <a:lvl1pPr marL="0" indent="0">
              <a:buNone/>
              <a:defRPr sz="4267">
                <a:solidFill>
                  <a:schemeClr val="bg1"/>
                </a:solidFill>
              </a:defRPr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279" y="13389254"/>
            <a:ext cx="10119360" cy="1347216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800"/>
              </a:spcAft>
              <a:buNone/>
              <a:defRPr sz="2000">
                <a:solidFill>
                  <a:srgbClr val="FFFFFF"/>
                </a:solidFill>
              </a:defRPr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915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14508480"/>
            <a:ext cx="12192001" cy="103632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" y="14357782"/>
            <a:ext cx="12192001" cy="14959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7280" y="649637"/>
            <a:ext cx="10058400" cy="328838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79" y="4183664"/>
            <a:ext cx="10058401" cy="9119616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7282" y="14642183"/>
            <a:ext cx="2472271" cy="8276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rgbClr val="FFFFFF"/>
                </a:solidFill>
              </a:defRPr>
            </a:lvl1pPr>
          </a:lstStyle>
          <a:p>
            <a:fld id="{0719EE56-AED3-4838-B927-4B139746B8C7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86186" y="14642183"/>
            <a:ext cx="4822804" cy="8276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 cap="all" baseline="0"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900460" y="14642183"/>
            <a:ext cx="1312025" cy="8276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0">
                <a:solidFill>
                  <a:srgbClr val="FFFFFF"/>
                </a:solidFill>
              </a:defRPr>
            </a:lvl1pPr>
          </a:lstStyle>
          <a:p>
            <a:fld id="{D2914E9A-B4F6-4BB0-AED4-9AE295875B9C}" type="slidenum">
              <a:rPr lang="en-US" smtClean="0"/>
              <a:t>‹#›</a:t>
            </a:fld>
            <a:endParaRPr lang="en-US"/>
          </a:p>
        </p:txBody>
      </p:sp>
      <p:cxnSp>
        <p:nvCxnSpPr>
          <p:cNvPr id="10" name="Straight Connector 9"/>
          <p:cNvCxnSpPr/>
          <p:nvPr/>
        </p:nvCxnSpPr>
        <p:spPr>
          <a:xfrm>
            <a:off x="1193532" y="3939115"/>
            <a:ext cx="996696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96208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1" r:id="rId1"/>
    <p:sldLayoutId id="2147483752" r:id="rId2"/>
    <p:sldLayoutId id="2147483753" r:id="rId3"/>
    <p:sldLayoutId id="2147483754" r:id="rId4"/>
    <p:sldLayoutId id="2147483755" r:id="rId5"/>
    <p:sldLayoutId id="2147483756" r:id="rId6"/>
    <p:sldLayoutId id="2147483757" r:id="rId7"/>
    <p:sldLayoutId id="2147483758" r:id="rId8"/>
    <p:sldLayoutId id="2147483759" r:id="rId9"/>
    <p:sldLayoutId id="2147483760" r:id="rId10"/>
    <p:sldLayoutId id="2147483761" r:id="rId11"/>
  </p:sldLayoutIdLst>
  <p:txStyles>
    <p:titleStyle>
      <a:lvl1pPr algn="l" defTabSz="1219170" rtl="0" eaLnBrk="1" latinLnBrk="0" hangingPunct="1">
        <a:lnSpc>
          <a:spcPct val="85000"/>
        </a:lnSpc>
        <a:spcBef>
          <a:spcPct val="0"/>
        </a:spcBef>
        <a:buNone/>
        <a:defRPr sz="6400" kern="1200" spc="-67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121917" indent="-121917" algn="l" defTabSz="1219170" rtl="0" eaLnBrk="1" latinLnBrk="0" hangingPunct="1">
        <a:lnSpc>
          <a:spcPct val="90000"/>
        </a:lnSpc>
        <a:spcBef>
          <a:spcPts val="1600"/>
        </a:spcBef>
        <a:spcAft>
          <a:spcPts val="267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6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512051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2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755885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999719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1243553" indent="-243834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46663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73329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99995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2266610" indent="-304792" algn="l" defTabSz="1219170" rtl="0" eaLnBrk="1" latinLnBrk="0" hangingPunct="1">
        <a:lnSpc>
          <a:spcPct val="90000"/>
        </a:lnSpc>
        <a:spcBef>
          <a:spcPts val="267"/>
        </a:spcBef>
        <a:spcAft>
          <a:spcPts val="533"/>
        </a:spcAft>
        <a:buClr>
          <a:schemeClr val="accent1"/>
        </a:buClr>
        <a:buFont typeface="Calibri" pitchFamily="34" charset="0"/>
        <a:buChar char="◦"/>
        <a:defRPr sz="1867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"/>
          <p:cNvSpPr txBox="1">
            <a:spLocks noChangeArrowheads="1"/>
          </p:cNvSpPr>
          <p:nvPr/>
        </p:nvSpPr>
        <p:spPr bwMode="auto">
          <a:xfrm>
            <a:off x="4764291" y="1613071"/>
            <a:ext cx="2294237" cy="402262"/>
          </a:xfrm>
          <a:prstGeom prst="rect">
            <a:avLst/>
          </a:prstGeom>
          <a:ln w="15875">
            <a:headEnd/>
            <a:tailEnd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tients admitted with features of </a:t>
            </a:r>
            <a:r>
              <a:rPr lang="en-US" altLang="en-US" sz="1200" dirty="0" smtClean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ute pyelonephritis</a:t>
            </a:r>
            <a:endParaRPr lang="en-US" alt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 Box 17"/>
          <p:cNvSpPr txBox="1">
            <a:spLocks noChangeArrowheads="1"/>
          </p:cNvSpPr>
          <p:nvPr/>
        </p:nvSpPr>
        <p:spPr bwMode="auto">
          <a:xfrm>
            <a:off x="4760274" y="2298738"/>
            <a:ext cx="2298254" cy="447815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mpirical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tibiotic(s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itiated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y treating physician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 Box 22"/>
          <p:cNvSpPr txBox="1">
            <a:spLocks noChangeArrowheads="1"/>
          </p:cNvSpPr>
          <p:nvPr/>
        </p:nvSpPr>
        <p:spPr bwMode="auto">
          <a:xfrm>
            <a:off x="4760274" y="3743991"/>
            <a:ext cx="2298254" cy="572416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rine culture and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sceptibility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ort reviewed on Day 3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empirical treatment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14"/>
          <p:cNvSpPr txBox="1">
            <a:spLocks noChangeArrowheads="1"/>
          </p:cNvSpPr>
          <p:nvPr/>
        </p:nvSpPr>
        <p:spPr bwMode="auto">
          <a:xfrm>
            <a:off x="2458192" y="3743991"/>
            <a:ext cx="1591268" cy="572416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rine culture sterile/contaminated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 Box 24"/>
          <p:cNvSpPr txBox="1">
            <a:spLocks noChangeArrowheads="1"/>
          </p:cNvSpPr>
          <p:nvPr/>
        </p:nvSpPr>
        <p:spPr bwMode="auto">
          <a:xfrm>
            <a:off x="2784332" y="3148297"/>
            <a:ext cx="948394" cy="286208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t eligible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 Box 15"/>
          <p:cNvSpPr txBox="1">
            <a:spLocks noChangeArrowheads="1"/>
          </p:cNvSpPr>
          <p:nvPr/>
        </p:nvSpPr>
        <p:spPr bwMode="auto">
          <a:xfrm>
            <a:off x="4760274" y="3029958"/>
            <a:ext cx="2298254" cy="447815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ily assessment for clinical improvement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 Box 3"/>
          <p:cNvSpPr txBox="1">
            <a:spLocks noChangeArrowheads="1"/>
          </p:cNvSpPr>
          <p:nvPr/>
        </p:nvSpPr>
        <p:spPr bwMode="auto">
          <a:xfrm>
            <a:off x="6881653" y="5046624"/>
            <a:ext cx="2523603" cy="356239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ally improved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y Day 3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2"/>
          <p:cNvSpPr txBox="1">
            <a:spLocks noChangeArrowheads="1"/>
          </p:cNvSpPr>
          <p:nvPr/>
        </p:nvSpPr>
        <p:spPr bwMode="auto">
          <a:xfrm>
            <a:off x="6881652" y="5622912"/>
            <a:ext cx="2523604" cy="299700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ine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ulture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eated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 Day 4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 Box 2"/>
          <p:cNvSpPr txBox="1">
            <a:spLocks noChangeArrowheads="1"/>
          </p:cNvSpPr>
          <p:nvPr/>
        </p:nvSpPr>
        <p:spPr bwMode="auto">
          <a:xfrm>
            <a:off x="6896557" y="6119768"/>
            <a:ext cx="2528699" cy="503215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77724" tIns="38862" rIns="77724" bIns="38862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850"/>
              </a:spcAft>
            </a:pPr>
            <a:r>
              <a:rPr lang="en-IN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IN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tinued </a:t>
            </a:r>
            <a:r>
              <a:rPr lang="en-IN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al improvement on Day </a:t>
            </a:r>
            <a:r>
              <a:rPr lang="en-IN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 of empirical regimen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18"/>
          <p:cNvSpPr txBox="1">
            <a:spLocks noChangeArrowheads="1"/>
          </p:cNvSpPr>
          <p:nvPr/>
        </p:nvSpPr>
        <p:spPr bwMode="auto">
          <a:xfrm>
            <a:off x="2180638" y="5044754"/>
            <a:ext cx="2415114" cy="358110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al improvement by Day 3 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4"/>
          <p:cNvSpPr txBox="1">
            <a:spLocks noChangeArrowheads="1"/>
          </p:cNvSpPr>
          <p:nvPr/>
        </p:nvSpPr>
        <p:spPr bwMode="auto">
          <a:xfrm>
            <a:off x="2228138" y="5600053"/>
            <a:ext cx="2315972" cy="447815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tibiotic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gimen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vised by treating physician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 Box 6"/>
          <p:cNvSpPr txBox="1">
            <a:spLocks noChangeArrowheads="1"/>
          </p:cNvSpPr>
          <p:nvPr/>
        </p:nvSpPr>
        <p:spPr bwMode="auto">
          <a:xfrm>
            <a:off x="2216263" y="6249306"/>
            <a:ext cx="2315972" cy="447815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ine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ulture </a:t>
            </a:r>
            <a:r>
              <a:rPr lang="en-US" alt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eated </a:t>
            </a:r>
            <a:r>
              <a:rPr lang="en-US" alt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 Day 4 of revised regimen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 Box 1"/>
          <p:cNvSpPr txBox="1"/>
          <p:nvPr/>
        </p:nvSpPr>
        <p:spPr>
          <a:xfrm>
            <a:off x="4812628" y="8293983"/>
            <a:ext cx="1960736" cy="397394"/>
          </a:xfrm>
          <a:prstGeom prst="rect">
            <a:avLst/>
          </a:prstGeom>
          <a:solidFill>
            <a:sysClr val="window" lastClr="FFFFFF"/>
          </a:solidFill>
          <a:ln w="15875">
            <a:solidFill>
              <a:prstClr val="black"/>
            </a:solidFill>
          </a:ln>
          <a:effectLst/>
        </p:spPr>
        <p:txBody>
          <a:bodyPr rot="0" spcFirstLastPara="0" vert="horz" wrap="square" lIns="77724" tIns="38862" rIns="77724" bIns="38862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IN" sz="1200" kern="0" dirty="0" smtClean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ndomization on Day 7</a:t>
            </a:r>
          </a:p>
          <a:p>
            <a:pPr algn="ctr"/>
            <a:r>
              <a:rPr lang="en-IN" sz="1200" kern="0" dirty="0" smtClean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effective regimen</a:t>
            </a:r>
            <a:endParaRPr lang="en-US" sz="1200" kern="0" dirty="0">
              <a:solidFill>
                <a:sysClr val="windowText" lastClr="000000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 Box 2"/>
          <p:cNvSpPr txBox="1">
            <a:spLocks noChangeArrowheads="1"/>
          </p:cNvSpPr>
          <p:nvPr/>
        </p:nvSpPr>
        <p:spPr bwMode="auto">
          <a:xfrm>
            <a:off x="2233955" y="6961610"/>
            <a:ext cx="2264775" cy="503215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77724" tIns="38862" rIns="77724" bIns="38862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850"/>
              </a:spcAft>
            </a:pPr>
            <a:r>
              <a:rPr lang="en-IN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al </a:t>
            </a:r>
            <a:r>
              <a:rPr lang="en-IN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provement </a:t>
            </a:r>
            <a:r>
              <a:rPr lang="en-IN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y </a:t>
            </a:r>
            <a:r>
              <a:rPr lang="en-IN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y 7 of revised regimen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Straight Arrow Connector 141"/>
          <p:cNvCxnSpPr>
            <a:stCxn id="20" idx="2"/>
            <a:endCxn id="22" idx="0"/>
          </p:cNvCxnSpPr>
          <p:nvPr/>
        </p:nvCxnSpPr>
        <p:spPr>
          <a:xfrm flipH="1">
            <a:off x="3386124" y="5402864"/>
            <a:ext cx="2071" cy="197189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Arrow Connector 143"/>
          <p:cNvCxnSpPr>
            <a:stCxn id="4" idx="2"/>
            <a:endCxn id="6" idx="0"/>
          </p:cNvCxnSpPr>
          <p:nvPr/>
        </p:nvCxnSpPr>
        <p:spPr>
          <a:xfrm flipH="1">
            <a:off x="5909401" y="2015333"/>
            <a:ext cx="2009" cy="283405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Arrow Connector 145"/>
          <p:cNvCxnSpPr>
            <a:stCxn id="6" idx="2"/>
            <a:endCxn id="13" idx="0"/>
          </p:cNvCxnSpPr>
          <p:nvPr/>
        </p:nvCxnSpPr>
        <p:spPr>
          <a:xfrm>
            <a:off x="5909401" y="2746553"/>
            <a:ext cx="0" cy="283405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Arrow Connector 147"/>
          <p:cNvCxnSpPr>
            <a:stCxn id="13" idx="2"/>
            <a:endCxn id="8" idx="0"/>
          </p:cNvCxnSpPr>
          <p:nvPr/>
        </p:nvCxnSpPr>
        <p:spPr>
          <a:xfrm>
            <a:off x="5909401" y="3477773"/>
            <a:ext cx="0" cy="266218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Arrow Connector 149"/>
          <p:cNvCxnSpPr>
            <a:stCxn id="8" idx="1"/>
          </p:cNvCxnSpPr>
          <p:nvPr/>
        </p:nvCxnSpPr>
        <p:spPr>
          <a:xfrm flipH="1">
            <a:off x="4049460" y="4030199"/>
            <a:ext cx="710814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 Box 2"/>
          <p:cNvSpPr txBox="1">
            <a:spLocks noChangeArrowheads="1"/>
          </p:cNvSpPr>
          <p:nvPr/>
        </p:nvSpPr>
        <p:spPr bwMode="auto">
          <a:xfrm>
            <a:off x="3471801" y="9337316"/>
            <a:ext cx="1608113" cy="272832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77724" tIns="38862" rIns="77724" bIns="38862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850"/>
              </a:spcAft>
            </a:pPr>
            <a:r>
              <a:rPr lang="en-IN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uncated treatment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 Box 2"/>
          <p:cNvSpPr txBox="1">
            <a:spLocks noChangeArrowheads="1"/>
          </p:cNvSpPr>
          <p:nvPr/>
        </p:nvSpPr>
        <p:spPr bwMode="auto">
          <a:xfrm>
            <a:off x="6387734" y="9337246"/>
            <a:ext cx="1872322" cy="290849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77724" tIns="38862" rIns="77724" bIns="38862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850"/>
              </a:spcAft>
            </a:pP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inued treatment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 Box 2"/>
          <p:cNvSpPr txBox="1">
            <a:spLocks noChangeArrowheads="1"/>
          </p:cNvSpPr>
          <p:nvPr/>
        </p:nvSpPr>
        <p:spPr bwMode="auto">
          <a:xfrm>
            <a:off x="3471801" y="10103572"/>
            <a:ext cx="1608113" cy="290849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77724" tIns="38862" rIns="77724" bIns="38862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850"/>
              </a:spcAft>
            </a:pPr>
            <a:r>
              <a:rPr lang="en-IN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charged home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 Box 2"/>
          <p:cNvSpPr txBox="1">
            <a:spLocks noChangeArrowheads="1"/>
          </p:cNvSpPr>
          <p:nvPr/>
        </p:nvSpPr>
        <p:spPr bwMode="auto">
          <a:xfrm>
            <a:off x="6387734" y="10125809"/>
            <a:ext cx="1872322" cy="447815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77724" tIns="38862" rIns="77724" bIns="38862" anchor="t" anchorCtr="0">
            <a:spAutoFit/>
          </a:bodyPr>
          <a:lstStyle/>
          <a:p>
            <a:pPr algn="ctr"/>
            <a:r>
              <a:rPr lang="en-IN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en-IN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e regimen continued</a:t>
            </a:r>
          </a:p>
          <a:p>
            <a:pPr algn="ctr"/>
            <a:r>
              <a:rPr lang="en-IN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7 more days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 Box 2"/>
          <p:cNvSpPr txBox="1">
            <a:spLocks noChangeArrowheads="1"/>
          </p:cNvSpPr>
          <p:nvPr/>
        </p:nvSpPr>
        <p:spPr bwMode="auto">
          <a:xfrm>
            <a:off x="6387734" y="11067446"/>
            <a:ext cx="1872322" cy="290849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77724" tIns="38862" rIns="77724" bIns="38862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850"/>
              </a:spcAft>
            </a:pPr>
            <a:r>
              <a:rPr lang="en-IN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charged home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 Box 2"/>
          <p:cNvSpPr txBox="1">
            <a:spLocks noChangeArrowheads="1"/>
          </p:cNvSpPr>
          <p:nvPr/>
        </p:nvSpPr>
        <p:spPr bwMode="auto">
          <a:xfrm>
            <a:off x="3336591" y="11765662"/>
            <a:ext cx="5031231" cy="290849"/>
          </a:xfrm>
          <a:prstGeom prst="rect">
            <a:avLst/>
          </a:prstGeom>
          <a:solidFill>
            <a:srgbClr val="FFFFFF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77724" tIns="38862" rIns="77724" bIns="38862" anchor="t" anchorCtr="0">
            <a:spAutoFit/>
          </a:bodyPr>
          <a:lstStyle/>
          <a:p>
            <a:pPr algn="ctr">
              <a:lnSpc>
                <a:spcPct val="115000"/>
              </a:lnSpc>
              <a:spcAft>
                <a:spcPts val="850"/>
              </a:spcAft>
            </a:pPr>
            <a:r>
              <a:rPr lang="en-IN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llow-up clinical assessment and urine cultures at Week 1 and Week 6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 rot="16200000">
            <a:off x="5821892" y="5694586"/>
            <a:ext cx="1614223" cy="307503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mpirical regimen</a:t>
            </a:r>
            <a:endParaRPr 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 rot="16200000">
            <a:off x="1127182" y="6018751"/>
            <a:ext cx="1728465" cy="307503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ised regimen</a:t>
            </a:r>
            <a:endParaRPr 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>
            <a:off x="3386123" y="4614522"/>
            <a:ext cx="475733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>
            <a:off x="8144696" y="4614522"/>
            <a:ext cx="1" cy="432102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/>
          <p:nvPr/>
        </p:nvCxnSpPr>
        <p:spPr>
          <a:xfrm>
            <a:off x="3383596" y="4618060"/>
            <a:ext cx="1" cy="432102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>
            <a:stCxn id="8" idx="2"/>
          </p:cNvCxnSpPr>
          <p:nvPr/>
        </p:nvCxnSpPr>
        <p:spPr>
          <a:xfrm>
            <a:off x="5909401" y="4316407"/>
            <a:ext cx="0" cy="298115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/>
          <p:nvPr/>
        </p:nvCxnSpPr>
        <p:spPr>
          <a:xfrm>
            <a:off x="8142451" y="5406402"/>
            <a:ext cx="0" cy="197189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/>
          <p:cNvCxnSpPr/>
          <p:nvPr/>
        </p:nvCxnSpPr>
        <p:spPr>
          <a:xfrm>
            <a:off x="3368396" y="6054997"/>
            <a:ext cx="0" cy="197189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/>
          <p:nvPr/>
        </p:nvCxnSpPr>
        <p:spPr>
          <a:xfrm flipH="1">
            <a:off x="6782755" y="6630357"/>
            <a:ext cx="1378152" cy="1653609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>
            <a:off x="3366343" y="7472199"/>
            <a:ext cx="1446285" cy="820449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4264763" y="8986375"/>
            <a:ext cx="304960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/>
          <p:nvPr/>
        </p:nvCxnSpPr>
        <p:spPr>
          <a:xfrm>
            <a:off x="4273031" y="9606135"/>
            <a:ext cx="0" cy="495405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/>
          <p:nvPr/>
        </p:nvCxnSpPr>
        <p:spPr>
          <a:xfrm>
            <a:off x="7328114" y="9633944"/>
            <a:ext cx="0" cy="495405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/>
          <p:cNvCxnSpPr/>
          <p:nvPr/>
        </p:nvCxnSpPr>
        <p:spPr>
          <a:xfrm>
            <a:off x="7324579" y="10578107"/>
            <a:ext cx="0" cy="495405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4274293" y="10394428"/>
            <a:ext cx="0" cy="1371241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/>
          <p:nvPr/>
        </p:nvCxnSpPr>
        <p:spPr>
          <a:xfrm>
            <a:off x="7324341" y="11358296"/>
            <a:ext cx="0" cy="407367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3367764" y="6697129"/>
            <a:ext cx="0" cy="264489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5787197" y="8691377"/>
            <a:ext cx="0" cy="29289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4271203" y="8986375"/>
            <a:ext cx="0" cy="350871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>
            <a:off x="7311178" y="8991069"/>
            <a:ext cx="0" cy="350871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V="1">
            <a:off x="3253884" y="3434505"/>
            <a:ext cx="0" cy="309486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Freeform 31"/>
          <p:cNvSpPr/>
          <p:nvPr/>
        </p:nvSpPr>
        <p:spPr>
          <a:xfrm>
            <a:off x="7062537" y="1816768"/>
            <a:ext cx="1114171" cy="2237874"/>
          </a:xfrm>
          <a:custGeom>
            <a:avLst/>
            <a:gdLst>
              <a:gd name="connsiteX0" fmla="*/ 0 w 1114171"/>
              <a:gd name="connsiteY0" fmla="*/ 0 h 2237874"/>
              <a:gd name="connsiteX1" fmla="*/ 902368 w 1114171"/>
              <a:gd name="connsiteY1" fmla="*/ 541421 h 2237874"/>
              <a:gd name="connsiteX2" fmla="*/ 1046747 w 1114171"/>
              <a:gd name="connsiteY2" fmla="*/ 1768643 h 2237874"/>
              <a:gd name="connsiteX3" fmla="*/ 12031 w 1114171"/>
              <a:gd name="connsiteY3" fmla="*/ 2237874 h 223787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14171" h="2237874">
                <a:moveTo>
                  <a:pt x="0" y="0"/>
                </a:moveTo>
                <a:cubicBezTo>
                  <a:pt x="363955" y="123323"/>
                  <a:pt x="727910" y="246647"/>
                  <a:pt x="902368" y="541421"/>
                </a:cubicBezTo>
                <a:cubicBezTo>
                  <a:pt x="1076826" y="836195"/>
                  <a:pt x="1195136" y="1485901"/>
                  <a:pt x="1046747" y="1768643"/>
                </a:cubicBezTo>
                <a:cubicBezTo>
                  <a:pt x="898358" y="2051385"/>
                  <a:pt x="455194" y="2144629"/>
                  <a:pt x="12031" y="2237874"/>
                </a:cubicBezTo>
              </a:path>
            </a:pathLst>
          </a:custGeom>
          <a:noFill/>
          <a:ln>
            <a:solidFill>
              <a:schemeClr val="tx1"/>
            </a:solidFill>
            <a:prstDash val="sysDash"/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 Box 24"/>
          <p:cNvSpPr txBox="1">
            <a:spLocks noChangeArrowheads="1"/>
          </p:cNvSpPr>
          <p:nvPr/>
        </p:nvSpPr>
        <p:spPr bwMode="auto">
          <a:xfrm>
            <a:off x="7472007" y="2650988"/>
            <a:ext cx="1323067" cy="465391"/>
          </a:xfrm>
          <a:prstGeom prst="rect">
            <a:avLst/>
          </a:prstGeom>
          <a:solidFill>
            <a:schemeClr val="bg1"/>
          </a:solidFill>
          <a:ln w="158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77724" tIns="38862" rIns="77724" bIns="38862" numCol="1" anchor="t" anchorCtr="0" compatLnSpc="1">
            <a:prstTxWarp prst="textNoShape">
              <a:avLst/>
            </a:prstTxWarp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etreatment urine culture sent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Arrow Connector 51"/>
          <p:cNvCxnSpPr/>
          <p:nvPr/>
        </p:nvCxnSpPr>
        <p:spPr>
          <a:xfrm>
            <a:off x="8140920" y="5918631"/>
            <a:ext cx="0" cy="197189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594284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Retrospect">
  <a:themeElements>
    <a:clrScheme name="Retrospect">
      <a:dk1>
        <a:srgbClr val="000000"/>
      </a:dk1>
      <a:lt1>
        <a:sysClr val="window" lastClr="FFFFFF"/>
      </a:lt1>
      <a:dk2>
        <a:srgbClr val="637052"/>
      </a:dk2>
      <a:lt2>
        <a:srgbClr val="CCDDEA"/>
      </a:lt2>
      <a:accent1>
        <a:srgbClr val="E48312"/>
      </a:accent1>
      <a:accent2>
        <a:srgbClr val="BD582C"/>
      </a:accent2>
      <a:accent3>
        <a:srgbClr val="865640"/>
      </a:accent3>
      <a:accent4>
        <a:srgbClr val="9B8357"/>
      </a:accent4>
      <a:accent5>
        <a:srgbClr val="C2BC80"/>
      </a:accent5>
      <a:accent6>
        <a:srgbClr val="94A088"/>
      </a:accent6>
      <a:hlink>
        <a:srgbClr val="2998E3"/>
      </a:hlink>
      <a:folHlink>
        <a:srgbClr val="8C8C8C"/>
      </a:folHlink>
    </a:clrScheme>
    <a:fontScheme name="Retrospect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etrospect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3F1AAB62-24C6-49D2-8E01-B56FAC9A3DCD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Retrospect</Template>
  <TotalTime>390</TotalTime>
  <Words>127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Retrospect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67</cp:revision>
  <dcterms:created xsi:type="dcterms:W3CDTF">2017-03-19T08:46:53Z</dcterms:created>
  <dcterms:modified xsi:type="dcterms:W3CDTF">2018-01-20T14:49:56Z</dcterms:modified>
</cp:coreProperties>
</file>